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119813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713"/>
  </p:normalViewPr>
  <p:slideViewPr>
    <p:cSldViewPr snapToGrid="0" snapToObjects="1">
      <p:cViewPr varScale="1">
        <p:scale>
          <a:sx n="90" d="100"/>
          <a:sy n="90" d="100"/>
        </p:scale>
        <p:origin x="312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zo Masters" userId="fef75e96-d40c-411b-a782-fc06d32d6a6f" providerId="ADAL" clId="{8398DF19-D378-4F17-86D9-B9DEA0A9D789}"/>
    <pc:docChg chg="modSld">
      <pc:chgData name="Lizo Masters" userId="fef75e96-d40c-411b-a782-fc06d32d6a6f" providerId="ADAL" clId="{8398DF19-D378-4F17-86D9-B9DEA0A9D789}" dt="2023-11-30T11:53:09.033" v="4" actId="114"/>
      <pc:docMkLst>
        <pc:docMk/>
      </pc:docMkLst>
      <pc:sldChg chg="modSp mod">
        <pc:chgData name="Lizo Masters" userId="fef75e96-d40c-411b-a782-fc06d32d6a6f" providerId="ADAL" clId="{8398DF19-D378-4F17-86D9-B9DEA0A9D789}" dt="2023-11-30T11:53:09.033" v="4" actId="114"/>
        <pc:sldMkLst>
          <pc:docMk/>
          <pc:sldMk cId="3750757118" sldId="256"/>
        </pc:sldMkLst>
        <pc:spChg chg="mod">
          <ac:chgData name="Lizo Masters" userId="fef75e96-d40c-411b-a782-fc06d32d6a6f" providerId="ADAL" clId="{8398DF19-D378-4F17-86D9-B9DEA0A9D789}" dt="2023-11-30T11:53:09.033" v="4" actId="114"/>
          <ac:spMkLst>
            <pc:docMk/>
            <pc:sldMk cId="3750757118" sldId="256"/>
            <ac:spMk id="16" creationId="{B46CEDF0-BBE4-2C44-B217-43F6ECF8C4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55149"/>
            <a:ext cx="5201841" cy="2882806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349128"/>
            <a:ext cx="4589860" cy="1999179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56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516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40855"/>
            <a:ext cx="1319585" cy="70172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40855"/>
            <a:ext cx="3882256" cy="70172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751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764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64352"/>
            <a:ext cx="5278339" cy="3444416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541353"/>
            <a:ext cx="5278339" cy="1811337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309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204273"/>
            <a:ext cx="2600921" cy="52538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204273"/>
            <a:ext cx="2600921" cy="52538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919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40856"/>
            <a:ext cx="5278339" cy="1600495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2029849"/>
            <a:ext cx="2588967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3024646"/>
            <a:ext cx="2588967" cy="444879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2029849"/>
            <a:ext cx="2601718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3024646"/>
            <a:ext cx="2601718" cy="444879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910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920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1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92226"/>
            <a:ext cx="3098155" cy="588445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012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92226"/>
            <a:ext cx="3098155" cy="588445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13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40856"/>
            <a:ext cx="5278339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204273"/>
            <a:ext cx="5278339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674706"/>
            <a:ext cx="206543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661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C080DF78-1BAA-024F-8C13-FED81AB9001F}"/>
              </a:ext>
            </a:extLst>
          </p:cNvPr>
          <p:cNvSpPr txBox="1"/>
          <p:nvPr/>
        </p:nvSpPr>
        <p:spPr>
          <a:xfrm>
            <a:off x="67605" y="1172091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upplementary Figure </a:t>
            </a:r>
            <a:r>
              <a:rPr lang="en-US" dirty="0"/>
              <a:t>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BA406A2-597C-0E48-BC34-E11575CB0603}"/>
              </a:ext>
            </a:extLst>
          </p:cNvPr>
          <p:cNvSpPr txBox="1"/>
          <p:nvPr/>
        </p:nvSpPr>
        <p:spPr>
          <a:xfrm>
            <a:off x="67605" y="174666"/>
            <a:ext cx="1974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sters et al. </a:t>
            </a:r>
            <a:r>
              <a:rPr lang="en-US"/>
              <a:t>2024</a:t>
            </a:r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5C9A938-4FD0-8A41-82AB-0C5B2C9D51AB}"/>
              </a:ext>
            </a:extLst>
          </p:cNvPr>
          <p:cNvSpPr txBox="1"/>
          <p:nvPr/>
        </p:nvSpPr>
        <p:spPr>
          <a:xfrm>
            <a:off x="0" y="664075"/>
            <a:ext cx="5556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Evolutionary origins of the African forage grass </a:t>
            </a:r>
            <a:r>
              <a:rPr lang="en-US" i="1" dirty="0"/>
              <a:t>Urochloa</a:t>
            </a:r>
            <a:r>
              <a:rPr lang="en-US" dirty="0"/>
              <a:t> 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F1F41D8-9D36-C849-A040-0AE00094D9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2" y="1738825"/>
            <a:ext cx="6119813" cy="4329713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B46CEDF0-BBE4-2C44-B217-43F6ECF8C400}"/>
              </a:ext>
            </a:extLst>
          </p:cNvPr>
          <p:cNvSpPr txBox="1"/>
          <p:nvPr/>
        </p:nvSpPr>
        <p:spPr>
          <a:xfrm>
            <a:off x="326721" y="6404624"/>
            <a:ext cx="559439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/>
              <a:t>Number of samples with ploidy levels </a:t>
            </a:r>
            <a:r>
              <a:rPr lang="en-US" i="1" dirty="0"/>
              <a:t>x</a:t>
            </a:r>
            <a:r>
              <a:rPr lang="en-US" dirty="0"/>
              <a:t>2, </a:t>
            </a:r>
            <a:r>
              <a:rPr lang="en-US" i="1" dirty="0"/>
              <a:t>x</a:t>
            </a:r>
            <a:r>
              <a:rPr lang="en-US" dirty="0"/>
              <a:t>3, </a:t>
            </a:r>
            <a:r>
              <a:rPr lang="en-US" i="1" dirty="0"/>
              <a:t>x</a:t>
            </a:r>
            <a:r>
              <a:rPr lang="en-US" dirty="0"/>
              <a:t>4, </a:t>
            </a:r>
            <a:r>
              <a:rPr lang="en-US" i="1" dirty="0"/>
              <a:t>x</a:t>
            </a:r>
            <a:r>
              <a:rPr lang="en-US" dirty="0"/>
              <a:t>5, and </a:t>
            </a:r>
            <a:r>
              <a:rPr lang="en-US" i="1" dirty="0"/>
              <a:t>x</a:t>
            </a:r>
            <a:r>
              <a:rPr lang="en-US" dirty="0"/>
              <a:t>6 in the  sample dataset. Ploidy levels were taken from the Chromosome Count Database (</a:t>
            </a:r>
            <a:r>
              <a:rPr lang="en-GB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http://</a:t>
            </a:r>
            <a:r>
              <a:rPr lang="en-GB" sz="18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cdb.tau.ac.il</a:t>
            </a:r>
            <a:r>
              <a:rPr lang="en-GB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/</a:t>
            </a:r>
            <a:r>
              <a:rPr lang="en-US" dirty="0"/>
              <a:t>), from literature, or were estimated using the PATE pipeline (</a:t>
            </a:r>
            <a:r>
              <a:rPr lang="en-US" dirty="0" err="1"/>
              <a:t>Tiley</a:t>
            </a:r>
            <a:r>
              <a:rPr lang="en-US" dirty="0"/>
              <a:t> et al., 2018; 2021) </a:t>
            </a:r>
          </a:p>
        </p:txBody>
      </p:sp>
    </p:spTree>
    <p:extLst>
      <p:ext uri="{BB962C8B-B14F-4D97-AF65-F5344CB8AC3E}">
        <p14:creationId xmlns:p14="http://schemas.microsoft.com/office/powerpoint/2010/main" val="3750757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2</TotalTime>
  <Words>78</Words>
  <Application>Microsoft Macintosh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zo Masters</dc:creator>
  <cp:lastModifiedBy>Masters, Lizo E.</cp:lastModifiedBy>
  <cp:revision>12</cp:revision>
  <dcterms:created xsi:type="dcterms:W3CDTF">2023-06-01T15:27:18Z</dcterms:created>
  <dcterms:modified xsi:type="dcterms:W3CDTF">2024-01-25T16:16:50Z</dcterms:modified>
</cp:coreProperties>
</file>